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4879FE-F5A2-468C-A58D-55D10DC5507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7C9CD4-2F5B-4C85-89FC-638B6247D02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719863-1B24-4567-B2FD-089A54E951F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6BFFC6-D55F-44F6-B5E1-724214A3327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03C571-0F50-4846-93EC-A80CE457044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0DE116-2CC0-4A82-8A4B-2C8BB3D3E2E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3108C2-4502-42CA-AEE4-D50742F5A38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F0099E-FFD4-428D-92C4-B02A12CC043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858058-C38F-4343-B42E-DD5782619BA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4A1E22-137A-42E0-9783-B205040F7FD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299DB0-938F-4E5D-988D-4160C9F1207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2B5334-97CC-43A4-B602-C814B61DE7D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F9A01F1-C043-42C9-A632-216701B62BBF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uppo 2"/>
          <p:cNvGrpSpPr/>
          <p:nvPr/>
        </p:nvGrpSpPr>
        <p:grpSpPr>
          <a:xfrm>
            <a:off x="3417840" y="841320"/>
            <a:ext cx="2819520" cy="2290680"/>
            <a:chOff x="3417840" y="841320"/>
            <a:chExt cx="2819520" cy="2290680"/>
          </a:xfrm>
        </p:grpSpPr>
        <p:pic>
          <p:nvPicPr>
            <p:cNvPr id="42" name="Grafico 36" descr=""/>
            <p:cNvPicPr/>
            <p:nvPr/>
          </p:nvPicPr>
          <p:blipFill>
            <a:blip r:embed="rId1"/>
            <a:stretch/>
          </p:blipFill>
          <p:spPr>
            <a:xfrm>
              <a:off x="3590280" y="841320"/>
              <a:ext cx="2647080" cy="2290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CasellaDiTesto 8"/>
            <p:cNvSpPr/>
            <p:nvPr/>
          </p:nvSpPr>
          <p:spPr>
            <a:xfrm rot="16200000">
              <a:off x="2862360" y="1920240"/>
              <a:ext cx="1326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Relative gene expression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44" name="CasellaDiTesto 192"/>
          <p:cNvSpPr/>
          <p:nvPr/>
        </p:nvSpPr>
        <p:spPr>
          <a:xfrm>
            <a:off x="4737960" y="15840"/>
            <a:ext cx="2084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upplementary Figure 6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 Box 474"/>
          <p:cNvSpPr/>
          <p:nvPr/>
        </p:nvSpPr>
        <p:spPr>
          <a:xfrm>
            <a:off x="3141720" y="3502080"/>
            <a:ext cx="336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 Box 474"/>
          <p:cNvSpPr/>
          <p:nvPr/>
        </p:nvSpPr>
        <p:spPr>
          <a:xfrm>
            <a:off x="3141720" y="692280"/>
            <a:ext cx="336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 Box 474"/>
          <p:cNvSpPr/>
          <p:nvPr/>
        </p:nvSpPr>
        <p:spPr>
          <a:xfrm>
            <a:off x="512640" y="709560"/>
            <a:ext cx="336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CasellaDiTesto 27"/>
          <p:cNvSpPr/>
          <p:nvPr/>
        </p:nvSpPr>
        <p:spPr>
          <a:xfrm>
            <a:off x="4150800" y="782640"/>
            <a:ext cx="1029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it-IT" sz="800" spc="-1" strike="noStrike">
                <a:solidFill>
                  <a:srgbClr val="000000"/>
                </a:solidFill>
                <a:latin typeface="Arial"/>
              </a:rPr>
              <a:t>Real-time RT-PCR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9" name="Gruppo 1"/>
          <p:cNvGrpSpPr/>
          <p:nvPr/>
        </p:nvGrpSpPr>
        <p:grpSpPr>
          <a:xfrm>
            <a:off x="695160" y="828720"/>
            <a:ext cx="1714320" cy="1716480"/>
            <a:chOff x="695160" y="828720"/>
            <a:chExt cx="1714320" cy="1716480"/>
          </a:xfrm>
        </p:grpSpPr>
        <p:sp>
          <p:nvSpPr>
            <p:cNvPr id="50" name="CasellaDiTesto 11"/>
            <p:cNvSpPr/>
            <p:nvPr/>
          </p:nvSpPr>
          <p:spPr>
            <a:xfrm>
              <a:off x="730440" y="1027440"/>
              <a:ext cx="461160" cy="21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</a:t>
              </a:r>
              <a:r>
                <a:rPr b="0" lang="it-IT" sz="700" spc="-1" strike="noStrike">
                  <a:solidFill>
                    <a:srgbClr val="000000"/>
                  </a:solidFill>
                  <a:latin typeface="Arial"/>
                </a:rPr>
                <a:t>GCS</a:t>
              </a:r>
              <a:r>
                <a:rPr b="0" lang="it-IT" sz="700" spc="-1" strike="noStrike" baseline="-25000">
                  <a:solidFill>
                    <a:srgbClr val="000000"/>
                  </a:solidFill>
                  <a:latin typeface="Arial"/>
                </a:rPr>
                <a:t>H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CasellaDiTesto 16"/>
            <p:cNvSpPr/>
            <p:nvPr/>
          </p:nvSpPr>
          <p:spPr>
            <a:xfrm>
              <a:off x="739440" y="1276200"/>
              <a:ext cx="451800" cy="21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</a:t>
              </a:r>
              <a:r>
                <a:rPr b="0" lang="it-IT" sz="700" spc="-1" strike="noStrike">
                  <a:solidFill>
                    <a:srgbClr val="000000"/>
                  </a:solidFill>
                  <a:latin typeface="Arial"/>
                </a:rPr>
                <a:t>GCS</a:t>
              </a:r>
              <a:r>
                <a:rPr b="0" lang="it-IT" sz="700" spc="-1" strike="noStrike" baseline="-25000">
                  <a:solidFill>
                    <a:srgbClr val="000000"/>
                  </a:solidFill>
                  <a:latin typeface="Arial"/>
                </a:rPr>
                <a:t>L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CasellaDiTesto 17"/>
            <p:cNvSpPr/>
            <p:nvPr/>
          </p:nvSpPr>
          <p:spPr>
            <a:xfrm>
              <a:off x="695160" y="1521720"/>
              <a:ext cx="4960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Arial"/>
                </a:rPr>
                <a:t>GAPDH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CasellaDiTesto 1"/>
            <p:cNvSpPr/>
            <p:nvPr/>
          </p:nvSpPr>
          <p:spPr>
            <a:xfrm>
              <a:off x="1059840" y="828720"/>
              <a:ext cx="1349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it-IT" sz="800" spc="-1" strike="noStrike">
                  <a:solidFill>
                    <a:srgbClr val="000000"/>
                  </a:solidFill>
                  <a:latin typeface="Arial"/>
                </a:rPr>
                <a:t>Semiquantitative RT-PCR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54" name="Picture 35" descr=""/>
            <p:cNvPicPr/>
            <p:nvPr/>
          </p:nvPicPr>
          <p:blipFill>
            <a:blip r:embed="rId2"/>
            <a:stretch/>
          </p:blipFill>
          <p:spPr>
            <a:xfrm>
              <a:off x="1182600" y="1022040"/>
              <a:ext cx="1067400" cy="781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5" name="CasellaDiTesto 18"/>
            <p:cNvSpPr/>
            <p:nvPr/>
          </p:nvSpPr>
          <p:spPr>
            <a:xfrm rot="16200000">
              <a:off x="1158480" y="1746000"/>
              <a:ext cx="2995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Arial"/>
                </a:rPr>
                <a:t>EV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CasellaDiTesto 20"/>
            <p:cNvSpPr/>
            <p:nvPr/>
          </p:nvSpPr>
          <p:spPr>
            <a:xfrm rot="16200000">
              <a:off x="1291320" y="1874160"/>
              <a:ext cx="5418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Arial"/>
                </a:rPr>
                <a:t>USP2a</a:t>
              </a:r>
              <a:r>
                <a:rPr b="0" lang="it-IT" sz="700" spc="-1" strike="noStrike" baseline="30000">
                  <a:solidFill>
                    <a:srgbClr val="000000"/>
                  </a:solidFill>
                  <a:latin typeface="Arial"/>
                </a:rPr>
                <a:t>WT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CasellaDiTesto 21"/>
            <p:cNvSpPr/>
            <p:nvPr/>
          </p:nvSpPr>
          <p:spPr>
            <a:xfrm rot="16200000">
              <a:off x="1395000" y="2015640"/>
              <a:ext cx="819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Arial"/>
                </a:rPr>
                <a:t>USP2a</a:t>
              </a:r>
              <a:r>
                <a:rPr b="0" lang="it-IT" sz="700" spc="-1" strike="noStrike" baseline="30000">
                  <a:solidFill>
                    <a:srgbClr val="000000"/>
                  </a:solidFill>
                  <a:latin typeface="Arial"/>
                </a:rPr>
                <a:t>WT</a:t>
              </a:r>
              <a:r>
                <a:rPr b="0" lang="it-IT" sz="700" spc="-1" strike="noStrike">
                  <a:solidFill>
                    <a:srgbClr val="000000"/>
                  </a:solidFill>
                  <a:latin typeface="Arial"/>
                </a:rPr>
                <a:t>+siMyc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CasellaDiTesto 22"/>
            <p:cNvSpPr/>
            <p:nvPr/>
          </p:nvSpPr>
          <p:spPr>
            <a:xfrm rot="16200000">
              <a:off x="1670760" y="2025360"/>
              <a:ext cx="8391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Arial"/>
                </a:rPr>
                <a:t>USP2a</a:t>
              </a:r>
              <a:r>
                <a:rPr b="0" lang="it-IT" sz="700" spc="-1" strike="noStrike" baseline="30000">
                  <a:solidFill>
                    <a:srgbClr val="000000"/>
                  </a:solidFill>
                  <a:latin typeface="Arial"/>
                </a:rPr>
                <a:t>WT</a:t>
              </a:r>
              <a:r>
                <a:rPr b="0" lang="it-IT" sz="700" spc="-1" strike="noStrike">
                  <a:solidFill>
                    <a:srgbClr val="000000"/>
                  </a:solidFill>
                  <a:latin typeface="Arial"/>
                </a:rPr>
                <a:t>+siGFP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59" name="Gruppo 3"/>
          <p:cNvGrpSpPr/>
          <p:nvPr/>
        </p:nvGrpSpPr>
        <p:grpSpPr>
          <a:xfrm>
            <a:off x="3429000" y="3759120"/>
            <a:ext cx="2160720" cy="2105280"/>
            <a:chOff x="3429000" y="3759120"/>
            <a:chExt cx="2160720" cy="2105280"/>
          </a:xfrm>
        </p:grpSpPr>
        <p:pic>
          <p:nvPicPr>
            <p:cNvPr id="60" name="Grafico 38" descr=""/>
            <p:cNvPicPr/>
            <p:nvPr/>
          </p:nvPicPr>
          <p:blipFill>
            <a:blip r:embed="rId3"/>
            <a:stretch/>
          </p:blipFill>
          <p:spPr>
            <a:xfrm>
              <a:off x="3590280" y="3759120"/>
              <a:ext cx="1999440" cy="2105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1" name="CasellaDiTesto 25"/>
            <p:cNvSpPr/>
            <p:nvPr/>
          </p:nvSpPr>
          <p:spPr>
            <a:xfrm rot="16200000">
              <a:off x="2794680" y="4630320"/>
              <a:ext cx="1483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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GCS activity (U/mg protein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2" name="Text Box 474"/>
          <p:cNvSpPr/>
          <p:nvPr/>
        </p:nvSpPr>
        <p:spPr>
          <a:xfrm>
            <a:off x="512640" y="3502080"/>
            <a:ext cx="336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3" name="Gruppo 4"/>
          <p:cNvGrpSpPr/>
          <p:nvPr/>
        </p:nvGrpSpPr>
        <p:grpSpPr>
          <a:xfrm>
            <a:off x="785160" y="3924360"/>
            <a:ext cx="1420560" cy="1570680"/>
            <a:chOff x="785160" y="3924360"/>
            <a:chExt cx="1420560" cy="1570680"/>
          </a:xfrm>
        </p:grpSpPr>
        <p:sp>
          <p:nvSpPr>
            <p:cNvPr id="64" name="CasellaDiTesto 18"/>
            <p:cNvSpPr/>
            <p:nvPr/>
          </p:nvSpPr>
          <p:spPr>
            <a:xfrm rot="16200000">
              <a:off x="1174320" y="4696200"/>
              <a:ext cx="2995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Arial"/>
                </a:rPr>
                <a:t>EV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CasellaDiTesto 20"/>
            <p:cNvSpPr/>
            <p:nvPr/>
          </p:nvSpPr>
          <p:spPr>
            <a:xfrm rot="16200000">
              <a:off x="1305720" y="4824360"/>
              <a:ext cx="5418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Arial"/>
                </a:rPr>
                <a:t>USP2a</a:t>
              </a:r>
              <a:r>
                <a:rPr b="0" lang="it-IT" sz="700" spc="-1" strike="noStrike" baseline="30000">
                  <a:solidFill>
                    <a:srgbClr val="000000"/>
                  </a:solidFill>
                  <a:latin typeface="Arial"/>
                </a:rPr>
                <a:t>WT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CasellaDiTesto 21"/>
            <p:cNvSpPr/>
            <p:nvPr/>
          </p:nvSpPr>
          <p:spPr>
            <a:xfrm rot="16200000">
              <a:off x="1410120" y="4965120"/>
              <a:ext cx="819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Arial"/>
                </a:rPr>
                <a:t>USP2a</a:t>
              </a:r>
              <a:r>
                <a:rPr b="0" lang="it-IT" sz="700" spc="-1" strike="noStrike" baseline="30000">
                  <a:solidFill>
                    <a:srgbClr val="000000"/>
                  </a:solidFill>
                  <a:latin typeface="Arial"/>
                </a:rPr>
                <a:t>WT</a:t>
              </a:r>
              <a:r>
                <a:rPr b="0" lang="it-IT" sz="700" spc="-1" strike="noStrike">
                  <a:solidFill>
                    <a:srgbClr val="000000"/>
                  </a:solidFill>
                  <a:latin typeface="Arial"/>
                </a:rPr>
                <a:t>+siMyc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CasellaDiTesto 22"/>
            <p:cNvSpPr/>
            <p:nvPr/>
          </p:nvSpPr>
          <p:spPr>
            <a:xfrm rot="16200000">
              <a:off x="1685880" y="4975200"/>
              <a:ext cx="8391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Arial"/>
                </a:rPr>
                <a:t>USP2a</a:t>
              </a:r>
              <a:r>
                <a:rPr b="0" lang="it-IT" sz="700" spc="-1" strike="noStrike" baseline="30000">
                  <a:solidFill>
                    <a:srgbClr val="000000"/>
                  </a:solidFill>
                  <a:latin typeface="Arial"/>
                </a:rPr>
                <a:t>WT</a:t>
              </a:r>
              <a:r>
                <a:rPr b="0" lang="it-IT" sz="700" spc="-1" strike="noStrike">
                  <a:solidFill>
                    <a:srgbClr val="000000"/>
                  </a:solidFill>
                  <a:latin typeface="Arial"/>
                </a:rPr>
                <a:t>+siGFP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68" name="Picture 37" descr=""/>
            <p:cNvPicPr/>
            <p:nvPr/>
          </p:nvPicPr>
          <p:blipFill>
            <a:blip r:embed="rId4"/>
            <a:stretch/>
          </p:blipFill>
          <p:spPr>
            <a:xfrm>
              <a:off x="1204920" y="3924360"/>
              <a:ext cx="1000080" cy="215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9" name="CasellaDiTesto 11"/>
            <p:cNvSpPr/>
            <p:nvPr/>
          </p:nvSpPr>
          <p:spPr>
            <a:xfrm>
              <a:off x="785160" y="3932280"/>
              <a:ext cx="461160" cy="21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</a:t>
              </a:r>
              <a:r>
                <a:rPr b="0" lang="it-IT" sz="700" spc="-1" strike="noStrike">
                  <a:solidFill>
                    <a:srgbClr val="000000"/>
                  </a:solidFill>
                  <a:latin typeface="Arial"/>
                </a:rPr>
                <a:t>GCS</a:t>
              </a:r>
              <a:r>
                <a:rPr b="0" lang="it-IT" sz="700" spc="-1" strike="noStrike" baseline="-25000">
                  <a:solidFill>
                    <a:srgbClr val="000000"/>
                  </a:solidFill>
                  <a:latin typeface="Arial"/>
                </a:rPr>
                <a:t>H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70" name="Picture 36" descr=""/>
            <p:cNvPicPr/>
            <p:nvPr/>
          </p:nvPicPr>
          <p:blipFill>
            <a:blip r:embed="rId5"/>
            <a:stretch/>
          </p:blipFill>
          <p:spPr>
            <a:xfrm>
              <a:off x="1204920" y="4168800"/>
              <a:ext cx="1000080" cy="217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1" name="CasellaDiTesto 16"/>
            <p:cNvSpPr/>
            <p:nvPr/>
          </p:nvSpPr>
          <p:spPr>
            <a:xfrm>
              <a:off x="794520" y="4176720"/>
              <a:ext cx="451800" cy="21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</a:t>
              </a:r>
              <a:r>
                <a:rPr b="0" lang="it-IT" sz="700" spc="-1" strike="noStrike">
                  <a:solidFill>
                    <a:srgbClr val="000000"/>
                  </a:solidFill>
                  <a:latin typeface="Arial"/>
                </a:rPr>
                <a:t>GCS</a:t>
              </a:r>
              <a:r>
                <a:rPr b="0" lang="it-IT" sz="700" spc="-1" strike="noStrike" baseline="-25000">
                  <a:solidFill>
                    <a:srgbClr val="000000"/>
                  </a:solidFill>
                  <a:latin typeface="Arial"/>
                </a:rPr>
                <a:t>L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72" name="Picture 37" descr=""/>
            <p:cNvPicPr/>
            <p:nvPr/>
          </p:nvPicPr>
          <p:blipFill>
            <a:blip r:embed="rId6"/>
            <a:stretch/>
          </p:blipFill>
          <p:spPr>
            <a:xfrm>
              <a:off x="1208160" y="4411800"/>
              <a:ext cx="996840" cy="222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3" name="CasellaDiTesto 16"/>
            <p:cNvSpPr/>
            <p:nvPr/>
          </p:nvSpPr>
          <p:spPr>
            <a:xfrm>
              <a:off x="802440" y="4422600"/>
              <a:ext cx="4442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</a:t>
              </a:r>
              <a:r>
                <a:rPr b="0" lang="it-IT" sz="700" spc="-1" strike="noStrike">
                  <a:solidFill>
                    <a:srgbClr val="000000"/>
                  </a:solidFill>
                  <a:latin typeface="Arial"/>
                </a:rPr>
                <a:t>-actin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74" name="CasellaDiTesto 1"/>
          <p:cNvSpPr/>
          <p:nvPr/>
        </p:nvSpPr>
        <p:spPr>
          <a:xfrm>
            <a:off x="333360" y="6156360"/>
            <a:ext cx="6048360" cy="115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upplementary Figure 6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-Myc is directly involved in the modulation of 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GCS expression and activity driven by USP2a.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valuation of (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,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) mRNA levels,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31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(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) protein expression, and (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d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) enzyme activity of both heavy and light subunits of the 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GCS gene carried out in the LNCaP empty vector, pUSP2a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WT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, GFP-silenced (siGFP) and c-Myc-silenced (siMyc) pUSP2a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WT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cells.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CasellaDiTesto 37"/>
          <p:cNvSpPr/>
          <p:nvPr/>
        </p:nvSpPr>
        <p:spPr>
          <a:xfrm>
            <a:off x="4390920" y="3711600"/>
            <a:ext cx="508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</a:rPr>
              <a:t>LNCaP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CasellaDiTesto 40"/>
          <p:cNvSpPr/>
          <p:nvPr/>
        </p:nvSpPr>
        <p:spPr>
          <a:xfrm>
            <a:off x="1467360" y="2475000"/>
            <a:ext cx="508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</a:rPr>
              <a:t>LNCaP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CasellaDiTesto 41"/>
          <p:cNvSpPr/>
          <p:nvPr/>
        </p:nvSpPr>
        <p:spPr>
          <a:xfrm>
            <a:off x="3756600" y="971640"/>
            <a:ext cx="508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</a:rPr>
              <a:t>LNCaP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Connettore 1 7"/>
          <p:cNvSpPr/>
          <p:nvPr/>
        </p:nvSpPr>
        <p:spPr>
          <a:xfrm>
            <a:off x="1228680" y="2498760"/>
            <a:ext cx="9349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CasellaDiTesto 46"/>
          <p:cNvSpPr/>
          <p:nvPr/>
        </p:nvSpPr>
        <p:spPr>
          <a:xfrm>
            <a:off x="1504800" y="5451480"/>
            <a:ext cx="508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</a:rPr>
              <a:t>LNCaP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Connettore 1 47"/>
          <p:cNvSpPr/>
          <p:nvPr/>
        </p:nvSpPr>
        <p:spPr>
          <a:xfrm>
            <a:off x="1265400" y="5475240"/>
            <a:ext cx="9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5-26T08:38:50Z</dcterms:created>
  <dc:creator>BarbaraB</dc:creator>
  <dc:description/>
  <dc:language>en-US</dc:language>
  <cp:lastModifiedBy>BarbaraB</cp:lastModifiedBy>
  <dcterms:modified xsi:type="dcterms:W3CDTF">2013-06-19T07:58:08Z</dcterms:modified>
  <cp:revision>37</cp:revision>
  <dc:subject/>
  <dc:title>Presentazione standard di PowerPoint</dc:title>
</cp:coreProperties>
</file>